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13">
            <a:extLst>
              <a:ext uri="{FF2B5EF4-FFF2-40B4-BE49-F238E27FC236}">
                <a16:creationId xmlns:a16="http://schemas.microsoft.com/office/drawing/2014/main" id="{C2797EB8-62AD-4BE7-A07F-DCED684B8F41}"/>
              </a:ext>
            </a:extLst>
          </p:cNvPr>
          <p:cNvSpPr txBox="1"/>
          <p:nvPr/>
        </p:nvSpPr>
        <p:spPr>
          <a:xfrm>
            <a:off x="718278" y="3804095"/>
            <a:ext cx="55841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ifying 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ectopic expression of ESR1-CCDC170 fusion protein products and wtCCDC170 proteins in respective engineered T47D cells lines by Western Blot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Group 53"/>
          <p:cNvGrpSpPr/>
          <p:nvPr/>
        </p:nvGrpSpPr>
        <p:grpSpPr>
          <a:xfrm>
            <a:off x="1277808" y="1127061"/>
            <a:ext cx="3332460" cy="2332889"/>
            <a:chOff x="310908" y="1325624"/>
            <a:chExt cx="3332460" cy="2332889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93" t="57174" r="44025" b="37242"/>
            <a:stretch/>
          </p:blipFill>
          <p:spPr>
            <a:xfrm>
              <a:off x="997651" y="2955341"/>
              <a:ext cx="2289772" cy="2392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61" name="Group 60"/>
            <p:cNvGrpSpPr/>
            <p:nvPr/>
          </p:nvGrpSpPr>
          <p:grpSpPr>
            <a:xfrm>
              <a:off x="310908" y="1325624"/>
              <a:ext cx="2897824" cy="2229105"/>
              <a:chOff x="326871" y="1968984"/>
              <a:chExt cx="3194581" cy="2662783"/>
            </a:xfrm>
          </p:grpSpPr>
          <p:sp>
            <p:nvSpPr>
              <p:cNvPr id="74" name="TextBox 73"/>
              <p:cNvSpPr txBox="1"/>
              <p:nvPr/>
            </p:nvSpPr>
            <p:spPr>
              <a:xfrm>
                <a:off x="474869" y="4356026"/>
                <a:ext cx="684734" cy="275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GAPDH</a:t>
                </a:r>
              </a:p>
            </p:txBody>
          </p:sp>
          <p:grpSp>
            <p:nvGrpSpPr>
              <p:cNvPr id="75" name="Group 74"/>
              <p:cNvGrpSpPr/>
              <p:nvPr/>
            </p:nvGrpSpPr>
            <p:grpSpPr>
              <a:xfrm>
                <a:off x="326871" y="1968984"/>
                <a:ext cx="3194581" cy="2240561"/>
                <a:chOff x="326871" y="1968984"/>
                <a:chExt cx="3194581" cy="2240561"/>
              </a:xfrm>
            </p:grpSpPr>
            <p:sp>
              <p:nvSpPr>
                <p:cNvPr id="76" name="TextBox 75"/>
                <p:cNvSpPr txBox="1"/>
                <p:nvPr/>
              </p:nvSpPr>
              <p:spPr>
                <a:xfrm rot="16200000">
                  <a:off x="3084773" y="2199699"/>
                  <a:ext cx="618887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Vector</a:t>
                  </a: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 rot="16200000">
                  <a:off x="1428864" y="2230340"/>
                  <a:ext cx="603568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6</a:t>
                  </a: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 rot="16200000">
                  <a:off x="1883602" y="2240547"/>
                  <a:ext cx="603568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7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 rot="16200000">
                  <a:off x="2286547" y="2240547"/>
                  <a:ext cx="603568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8</a:t>
                  </a: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 rot="16200000">
                  <a:off x="2651193" y="2181830"/>
                  <a:ext cx="680163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10</a:t>
                  </a: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 rot="16200000">
                  <a:off x="1100263" y="2281402"/>
                  <a:ext cx="435058" cy="25447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WT</a:t>
                  </a: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326871" y="2770982"/>
                  <a:ext cx="783206" cy="2757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CCDC170</a:t>
                  </a: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510921" y="3138248"/>
                  <a:ext cx="557010" cy="2757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6</a:t>
                  </a: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98094" y="3303930"/>
                  <a:ext cx="557010" cy="2757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7</a:t>
                  </a: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498094" y="3595631"/>
                  <a:ext cx="557010" cy="2757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/>
                    <a:t>E2-E8</a:t>
                  </a: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474869" y="3933804"/>
                  <a:ext cx="684732" cy="275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E2-E10</a:t>
                  </a:r>
                </a:p>
              </p:txBody>
            </p:sp>
          </p:grpSp>
        </p:grpSp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30" t="33521" r="47018" b="57629"/>
            <a:stretch/>
          </p:blipFill>
          <p:spPr>
            <a:xfrm>
              <a:off x="997651" y="3241395"/>
              <a:ext cx="2300054" cy="4171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25" t="6795" r="44026" b="84844"/>
            <a:stretch/>
          </p:blipFill>
          <p:spPr>
            <a:xfrm>
              <a:off x="999515" y="1892867"/>
              <a:ext cx="2289772" cy="37067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5" name="Rectangle 64"/>
            <p:cNvSpPr/>
            <p:nvPr/>
          </p:nvSpPr>
          <p:spPr>
            <a:xfrm>
              <a:off x="3216413" y="1610316"/>
              <a:ext cx="3898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623438">
                <a:defRPr/>
              </a:pPr>
              <a:r>
                <a:rPr lang="en-US" sz="900" kern="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Arrow Connector 325">
              <a:extLst>
                <a:ext uri="{FF2B5EF4-FFF2-40B4-BE49-F238E27FC236}">
                  <a16:creationId xmlns:a16="http://schemas.microsoft.com/office/drawing/2014/main" id="{477BE1F7-D704-4101-B78C-5636F169F9EE}"/>
                </a:ext>
              </a:extLst>
            </p:cNvPr>
            <p:cNvCxnSpPr/>
            <p:nvPr/>
          </p:nvCxnSpPr>
          <p:spPr>
            <a:xfrm flipH="1">
              <a:off x="3293306" y="3077853"/>
              <a:ext cx="477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Arrow Connector 325">
              <a:extLst>
                <a:ext uri="{FF2B5EF4-FFF2-40B4-BE49-F238E27FC236}">
                  <a16:creationId xmlns:a16="http://schemas.microsoft.com/office/drawing/2014/main" id="{477BE1F7-D704-4101-B78C-5636F169F9EE}"/>
                </a:ext>
              </a:extLst>
            </p:cNvPr>
            <p:cNvCxnSpPr/>
            <p:nvPr/>
          </p:nvCxnSpPr>
          <p:spPr>
            <a:xfrm flipH="1">
              <a:off x="3296331" y="2126793"/>
              <a:ext cx="477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Straight Arrow Connector 325">
              <a:extLst>
                <a:ext uri="{FF2B5EF4-FFF2-40B4-BE49-F238E27FC236}">
                  <a16:creationId xmlns:a16="http://schemas.microsoft.com/office/drawing/2014/main" id="{477BE1F7-D704-4101-B78C-5636F169F9EE}"/>
                </a:ext>
              </a:extLst>
            </p:cNvPr>
            <p:cNvCxnSpPr/>
            <p:nvPr/>
          </p:nvCxnSpPr>
          <p:spPr>
            <a:xfrm flipH="1">
              <a:off x="3289749" y="2545285"/>
              <a:ext cx="477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Arrow Connector 325">
              <a:extLst>
                <a:ext uri="{FF2B5EF4-FFF2-40B4-BE49-F238E27FC236}">
                  <a16:creationId xmlns:a16="http://schemas.microsoft.com/office/drawing/2014/main" id="{477BE1F7-D704-4101-B78C-5636F169F9EE}"/>
                </a:ext>
              </a:extLst>
            </p:cNvPr>
            <p:cNvCxnSpPr/>
            <p:nvPr/>
          </p:nvCxnSpPr>
          <p:spPr>
            <a:xfrm flipH="1">
              <a:off x="3282664" y="3458032"/>
              <a:ext cx="477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3302340" y="334592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308594" y="264513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319768" y="231465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330462" y="201656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11AAE3F-C784-45C3-AFAD-7399850C2136}"/>
                </a:ext>
              </a:extLst>
            </p:cNvPr>
            <p:cNvSpPr txBox="1"/>
            <p:nvPr/>
          </p:nvSpPr>
          <p:spPr>
            <a:xfrm>
              <a:off x="3320230" y="244315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7B078AC-3A81-40E4-921F-E9D79BDE6BC3}"/>
                </a:ext>
              </a:extLst>
            </p:cNvPr>
            <p:cNvSpPr txBox="1"/>
            <p:nvPr/>
          </p:nvSpPr>
          <p:spPr>
            <a:xfrm>
              <a:off x="3302340" y="297118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</p:grpSp>
      <p:cxnSp>
        <p:nvCxnSpPr>
          <p:cNvPr id="31" name="Straight Arrow Connector 325">
            <a:extLst>
              <a:ext uri="{FF2B5EF4-FFF2-40B4-BE49-F238E27FC236}">
                <a16:creationId xmlns:a16="http://schemas.microsoft.com/office/drawing/2014/main" id="{C18E0C4D-C5C7-42FD-B07D-4333680FE2F7}"/>
              </a:ext>
            </a:extLst>
          </p:cNvPr>
          <p:cNvCxnSpPr/>
          <p:nvPr/>
        </p:nvCxnSpPr>
        <p:spPr>
          <a:xfrm flipH="1">
            <a:off x="4264086" y="2242635"/>
            <a:ext cx="4779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3" name="Picture 32">
            <a:extLst>
              <a:ext uri="{FF2B5EF4-FFF2-40B4-BE49-F238E27FC236}">
                <a16:creationId xmlns:a16="http://schemas.microsoft.com/office/drawing/2014/main" id="{F268DB9F-FC9B-4777-ADB1-4501BDD3397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25" t="26579" r="44026" b="65798"/>
          <a:stretch/>
        </p:blipFill>
        <p:spPr>
          <a:xfrm>
            <a:off x="1965805" y="2126472"/>
            <a:ext cx="2289772" cy="3379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cxnSp>
        <p:nvCxnSpPr>
          <p:cNvPr id="34" name="Straight Arrow Connector 325">
            <a:extLst>
              <a:ext uri="{FF2B5EF4-FFF2-40B4-BE49-F238E27FC236}">
                <a16:creationId xmlns:a16="http://schemas.microsoft.com/office/drawing/2014/main" id="{123BB9C8-155A-4A80-B654-6F1188714DFC}"/>
              </a:ext>
            </a:extLst>
          </p:cNvPr>
          <p:cNvCxnSpPr/>
          <p:nvPr/>
        </p:nvCxnSpPr>
        <p:spPr>
          <a:xfrm flipH="1">
            <a:off x="4245341" y="2552194"/>
            <a:ext cx="4779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6" name="Picture 35">
            <a:extLst>
              <a:ext uri="{FF2B5EF4-FFF2-40B4-BE49-F238E27FC236}">
                <a16:creationId xmlns:a16="http://schemas.microsoft.com/office/drawing/2014/main" id="{3B5B3B58-3021-4D91-B452-CE5171FB063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25" t="35963" r="44026" b="59671"/>
          <a:stretch/>
        </p:blipFill>
        <p:spPr>
          <a:xfrm>
            <a:off x="1965805" y="2509033"/>
            <a:ext cx="2289772" cy="1935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46439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45</Words>
  <Application>Microsoft Office PowerPoint</Application>
  <PresentationFormat>信纸(8.5x11 英寸)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黑体</vt:lpstr>
      <vt:lpstr>Arial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0:51Z</dcterms:modified>
</cp:coreProperties>
</file>